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15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CEACAM5 </a:t>
            </a:r>
            <a:r>
              <a:rPr lang="en-GB" sz="1600" dirty="0" smtClean="0"/>
              <a:t>gene. A) Wild (Template</a:t>
            </a:r>
            <a:r>
              <a:rPr lang="en-US" sz="1600" dirty="0" smtClean="0"/>
              <a:t> 1e07_A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1e07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571604" y="179824"/>
            <a:ext cx="1480725" cy="26062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429256" y="142852"/>
            <a:ext cx="2571768" cy="3049834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8196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 flipH="1">
            <a:off x="1567863" y="3071810"/>
            <a:ext cx="1503939" cy="28581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197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429255" y="3286124"/>
            <a:ext cx="2571769" cy="2621609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59</cp:revision>
  <dcterms:created xsi:type="dcterms:W3CDTF">2018-05-10T07:33:24Z</dcterms:created>
  <dcterms:modified xsi:type="dcterms:W3CDTF">2018-05-29T06:55:20Z</dcterms:modified>
</cp:coreProperties>
</file>